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7" r:id="rId2"/>
    <p:sldId id="27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54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ACAFA589-50A7-4B23-8C3F-B4B2D5DFD8DA}"/>
              </a:ext>
            </a:extLst>
          </p:cNvPr>
          <p:cNvGrpSpPr/>
          <p:nvPr/>
        </p:nvGrpSpPr>
        <p:grpSpPr>
          <a:xfrm>
            <a:off x="1127901" y="389370"/>
            <a:ext cx="4469740" cy="8567062"/>
            <a:chOff x="1020325" y="254900"/>
            <a:chExt cx="4469740" cy="8567062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E58AAB1-FD23-4231-93D1-21DB824DA2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633"/>
            <a:stretch/>
          </p:blipFill>
          <p:spPr>
            <a:xfrm>
              <a:off x="1506071" y="466165"/>
              <a:ext cx="3935506" cy="5172636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7DC7F19-D04E-4755-AB6D-4380284BBD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493"/>
            <a:stretch/>
          </p:blipFill>
          <p:spPr>
            <a:xfrm>
              <a:off x="1515035" y="6176682"/>
              <a:ext cx="3926542" cy="2438400"/>
            </a:xfrm>
            <a:prstGeom prst="rect">
              <a:avLst/>
            </a:prstGeom>
          </p:spPr>
        </p:pic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3D5DACB6-A554-4CF6-B187-82E95DA120A2}"/>
                </a:ext>
              </a:extLst>
            </p:cNvPr>
            <p:cNvGrpSpPr/>
            <p:nvPr/>
          </p:nvGrpSpPr>
          <p:grpSpPr>
            <a:xfrm>
              <a:off x="1020325" y="254900"/>
              <a:ext cx="4469740" cy="8567062"/>
              <a:chOff x="1020325" y="254900"/>
              <a:chExt cx="4469740" cy="8567062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9935F502-5FD9-46DB-A835-F2317BAC7292}"/>
                  </a:ext>
                </a:extLst>
              </p:cNvPr>
              <p:cNvSpPr txBox="1"/>
              <p:nvPr/>
            </p:nvSpPr>
            <p:spPr>
              <a:xfrm>
                <a:off x="2293178" y="254900"/>
                <a:ext cx="282409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in the ribosome pathway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2DE4350-2C5E-4CB3-9854-F431C4C04435}"/>
                  </a:ext>
                </a:extLst>
              </p:cNvPr>
              <p:cNvSpPr txBox="1"/>
              <p:nvPr/>
            </p:nvSpPr>
            <p:spPr>
              <a:xfrm>
                <a:off x="2044237" y="5620104"/>
                <a:ext cx="33073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R1min         R30min        R45min           R6h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9041BDCA-3A34-408A-A3EF-01A51F665BAC}"/>
                  </a:ext>
                </a:extLst>
              </p:cNvPr>
              <p:cNvSpPr txBox="1"/>
              <p:nvPr/>
            </p:nvSpPr>
            <p:spPr>
              <a:xfrm>
                <a:off x="1020325" y="5911721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04A85254-BEC0-49AE-BC2E-226DE22B373C}"/>
                  </a:ext>
                </a:extLst>
              </p:cNvPr>
              <p:cNvSpPr txBox="1"/>
              <p:nvPr/>
            </p:nvSpPr>
            <p:spPr>
              <a:xfrm>
                <a:off x="2044237" y="8606518"/>
                <a:ext cx="33073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R1min         R30min        R45min           R6h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7E964FC6-B343-47D6-8D92-406496327CB0}"/>
                  </a:ext>
                </a:extLst>
              </p:cNvPr>
              <p:cNvSpPr txBox="1"/>
              <p:nvPr/>
            </p:nvSpPr>
            <p:spPr>
              <a:xfrm>
                <a:off x="1344320" y="5970831"/>
                <a:ext cx="414574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in the  protein processing in endoplasmic reticulum pathway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54BA8ABC-BC6D-4CA3-8B41-684AFBCAA120}"/>
                  </a:ext>
                </a:extLst>
              </p:cNvPr>
              <p:cNvSpPr txBox="1"/>
              <p:nvPr/>
            </p:nvSpPr>
            <p:spPr>
              <a:xfrm>
                <a:off x="1020325" y="254900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93259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5C15493F-4E77-4C36-89A3-007983EE9D91}"/>
              </a:ext>
            </a:extLst>
          </p:cNvPr>
          <p:cNvGrpSpPr/>
          <p:nvPr/>
        </p:nvGrpSpPr>
        <p:grpSpPr>
          <a:xfrm>
            <a:off x="1205945" y="269527"/>
            <a:ext cx="4581870" cy="5791566"/>
            <a:chOff x="1205945" y="269527"/>
            <a:chExt cx="4581870" cy="5791566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EA02C22F-B071-49EB-B62D-A8D7ED0BE7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32" b="7493"/>
            <a:stretch/>
          </p:blipFill>
          <p:spPr>
            <a:xfrm>
              <a:off x="1515035" y="4078941"/>
              <a:ext cx="3935505" cy="1757084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80428142-B07D-477E-823E-DE6EFA381E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913"/>
            <a:stretch/>
          </p:blipFill>
          <p:spPr>
            <a:xfrm>
              <a:off x="1508133" y="484093"/>
              <a:ext cx="3942408" cy="3056965"/>
            </a:xfrm>
            <a:prstGeom prst="rect">
              <a:avLst/>
            </a:prstGeom>
          </p:spPr>
        </p:pic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7B31CB9E-A8CB-4D69-9677-466EC332438C}"/>
                </a:ext>
              </a:extLst>
            </p:cNvPr>
            <p:cNvGrpSpPr/>
            <p:nvPr/>
          </p:nvGrpSpPr>
          <p:grpSpPr>
            <a:xfrm>
              <a:off x="1205945" y="269527"/>
              <a:ext cx="4551900" cy="3482695"/>
              <a:chOff x="1205945" y="269527"/>
              <a:chExt cx="4551900" cy="3482695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ADDC310E-EC29-407F-8FC4-988338269F6D}"/>
                  </a:ext>
                </a:extLst>
              </p:cNvPr>
              <p:cNvSpPr txBox="1"/>
              <p:nvPr/>
            </p:nvSpPr>
            <p:spPr>
              <a:xfrm>
                <a:off x="1205945" y="269527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DA83E55C-DA50-4CF9-9919-A254EE741949}"/>
                  </a:ext>
                </a:extLst>
              </p:cNvPr>
              <p:cNvSpPr txBox="1"/>
              <p:nvPr/>
            </p:nvSpPr>
            <p:spPr>
              <a:xfrm>
                <a:off x="2031315" y="3536778"/>
                <a:ext cx="33073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R1min         R30min       R45min           R6h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5548F779-9571-4549-B9EB-9222549398D1}"/>
                  </a:ext>
                </a:extLst>
              </p:cNvPr>
              <p:cNvSpPr txBox="1"/>
              <p:nvPr/>
            </p:nvSpPr>
            <p:spPr>
              <a:xfrm>
                <a:off x="1612100" y="269527"/>
                <a:ext cx="414574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as ribosomal components in plastid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99D6A703-910C-448E-ADCC-8D3A0563356B}"/>
                </a:ext>
              </a:extLst>
            </p:cNvPr>
            <p:cNvSpPr txBox="1"/>
            <p:nvPr/>
          </p:nvSpPr>
          <p:spPr>
            <a:xfrm>
              <a:off x="1252609" y="3878927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BE4A24F-BDD1-4BAC-A3A1-132D29C06F57}"/>
                </a:ext>
              </a:extLst>
            </p:cNvPr>
            <p:cNvSpPr txBox="1"/>
            <p:nvPr/>
          </p:nvSpPr>
          <p:spPr>
            <a:xfrm>
              <a:off x="2054376" y="5845649"/>
              <a:ext cx="33073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R1min         R30min      R45min           R6h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54BC2E11-4E5B-4AAC-84F7-6C7C3C595FC6}"/>
                </a:ext>
              </a:extLst>
            </p:cNvPr>
            <p:cNvSpPr txBox="1"/>
            <p:nvPr/>
          </p:nvSpPr>
          <p:spPr>
            <a:xfrm>
              <a:off x="1642070" y="3875115"/>
              <a:ext cx="4145745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as ribosomal components in mitochondria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51736B31-7032-4D21-B4CE-644DE9856930}"/>
              </a:ext>
            </a:extLst>
          </p:cNvPr>
          <p:cNvSpPr txBox="1"/>
          <p:nvPr/>
        </p:nvSpPr>
        <p:spPr>
          <a:xfrm>
            <a:off x="513229" y="6126703"/>
            <a:ext cx="614754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4.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ribosomal proteins and protein processing in endoplasmic reticulum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atmap representations of the expression of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ribosomal protein gene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genes related to the endoplasmic reticulum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plastid ribosomal gene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mitochondrial ribosomal genes during rehydration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105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19</TotalTime>
  <Words>121</Words>
  <Application>Microsoft Office PowerPoint</Application>
  <PresentationFormat>A4 纸张(210x297 毫米)</PresentationFormat>
  <Paragraphs>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02</cp:revision>
  <dcterms:created xsi:type="dcterms:W3CDTF">2021-01-19T12:49:28Z</dcterms:created>
  <dcterms:modified xsi:type="dcterms:W3CDTF">2023-01-10T11:14:51Z</dcterms:modified>
</cp:coreProperties>
</file>